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E:\Work\2.%20Post-Doc\2.%20MRC%20(Oxford)\Results\1.%20Utrophin%20Modulation\1.%20Trial%20A%20(353,%20357)\3.%20Protein\1.%20EDL\2.%20All%20samples\Results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'[353 357 256 C1100 LUCI and cell prolif Jan 2015.xlsx]cell prolif'!$V$68</c:f>
              <c:strCache>
                <c:ptCount val="1"/>
                <c:pt idx="0">
                  <c:v>SMT022357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'[353 357 256 C1100 LUCI and cell prolif Jan 2015.xlsx]cell prolif'!$V$88:$V$95</c:f>
                <c:numCache>
                  <c:formatCode>General</c:formatCode>
                  <c:ptCount val="8"/>
                  <c:pt idx="0">
                    <c:v>2.0636178227855149E-3</c:v>
                  </c:pt>
                  <c:pt idx="1">
                    <c:v>3.3692509333463866E-3</c:v>
                  </c:pt>
                  <c:pt idx="2">
                    <c:v>2.7255988129020778E-3</c:v>
                  </c:pt>
                  <c:pt idx="3">
                    <c:v>1.444529912002634E-3</c:v>
                  </c:pt>
                  <c:pt idx="4">
                    <c:v>2.5056972120572666E-3</c:v>
                  </c:pt>
                  <c:pt idx="5">
                    <c:v>3.703451843288482E-3</c:v>
                  </c:pt>
                  <c:pt idx="6">
                    <c:v>7.7793649173897843E-4</c:v>
                  </c:pt>
                  <c:pt idx="7">
                    <c:v>1.6329931618033901E-4</c:v>
                  </c:pt>
                </c:numCache>
              </c:numRef>
            </c:plus>
            <c:minus>
              <c:numRef>
                <c:f>'[353 357 256 C1100 LUCI and cell prolif Jan 2015.xlsx]cell prolif'!$V$88:$V$95</c:f>
                <c:numCache>
                  <c:formatCode>General</c:formatCode>
                  <c:ptCount val="8"/>
                  <c:pt idx="0">
                    <c:v>2.0636178227855149E-3</c:v>
                  </c:pt>
                  <c:pt idx="1">
                    <c:v>3.3692509333463866E-3</c:v>
                  </c:pt>
                  <c:pt idx="2">
                    <c:v>2.7255988129020778E-3</c:v>
                  </c:pt>
                  <c:pt idx="3">
                    <c:v>1.444529912002634E-3</c:v>
                  </c:pt>
                  <c:pt idx="4">
                    <c:v>2.5056972120572666E-3</c:v>
                  </c:pt>
                  <c:pt idx="5">
                    <c:v>3.703451843288482E-3</c:v>
                  </c:pt>
                  <c:pt idx="6">
                    <c:v>7.7793649173897843E-4</c:v>
                  </c:pt>
                  <c:pt idx="7">
                    <c:v>1.6329931618033901E-4</c:v>
                  </c:pt>
                </c:numCache>
              </c:numRef>
            </c:minus>
          </c:errBars>
          <c:cat>
            <c:numRef>
              <c:f>'[353 357 256 C1100 LUCI and cell prolif Jan 2015.xlsx]cell prolif'!$T$69:$T$75</c:f>
              <c:numCache>
                <c:formatCode>General</c:formatCode>
                <c:ptCount val="7"/>
                <c:pt idx="0">
                  <c:v>0.01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[353 357 256 C1100 LUCI and cell prolif Jan 2015.xlsx]cell prolif'!$V$69:$V$75</c:f>
              <c:numCache>
                <c:formatCode>0.000</c:formatCode>
                <c:ptCount val="7"/>
                <c:pt idx="0">
                  <c:v>0.25026666666666669</c:v>
                </c:pt>
                <c:pt idx="1">
                  <c:v>0.26273333333333332</c:v>
                </c:pt>
                <c:pt idx="2">
                  <c:v>0.2656</c:v>
                </c:pt>
                <c:pt idx="3">
                  <c:v>0.26019999999999999</c:v>
                </c:pt>
                <c:pt idx="4">
                  <c:v>0.25896666666666668</c:v>
                </c:pt>
                <c:pt idx="5">
                  <c:v>0.2571</c:v>
                </c:pt>
                <c:pt idx="6">
                  <c:v>0.256966666666666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08668912"/>
        <c:axId val="308669304"/>
      </c:barChart>
      <c:catAx>
        <c:axId val="30866891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00" b="1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GB" sz="1000" b="1">
                    <a:latin typeface="Times New Roman" pitchFamily="18" charset="0"/>
                    <a:cs typeface="Times New Roman" pitchFamily="18" charset="0"/>
                  </a:rPr>
                  <a:t>SMT022357</a:t>
                </a:r>
                <a:r>
                  <a:rPr lang="en-GB" sz="1000" b="1" baseline="0">
                    <a:latin typeface="Times New Roman" pitchFamily="18" charset="0"/>
                    <a:cs typeface="Times New Roman" pitchFamily="18" charset="0"/>
                  </a:rPr>
                  <a:t> concentration (</a:t>
                </a:r>
                <a:r>
                  <a:rPr lang="el-GR" sz="1000" b="1" baseline="0">
                    <a:latin typeface="Times New Roman" pitchFamily="18" charset="0"/>
                    <a:cs typeface="Times New Roman" pitchFamily="18" charset="0"/>
                  </a:rPr>
                  <a:t>μ</a:t>
                </a:r>
                <a:r>
                  <a:rPr lang="en-GB" sz="1000" b="1" baseline="0">
                    <a:latin typeface="Times New Roman" pitchFamily="18" charset="0"/>
                    <a:cs typeface="Times New Roman" pitchFamily="18" charset="0"/>
                  </a:rPr>
                  <a:t>M)</a:t>
                </a:r>
                <a:endParaRPr lang="en-GB" sz="1000" b="1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308669304"/>
        <c:crosses val="autoZero"/>
        <c:auto val="1"/>
        <c:lblAlgn val="ctr"/>
        <c:lblOffset val="100"/>
        <c:noMultiLvlLbl val="0"/>
      </c:catAx>
      <c:valAx>
        <c:axId val="308669304"/>
        <c:scaling>
          <c:orientation val="minMax"/>
          <c:max val="0.30000000000000004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1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GB" b="1">
                    <a:latin typeface="Times New Roman" pitchFamily="18" charset="0"/>
                    <a:cs typeface="Times New Roman" pitchFamily="18" charset="0"/>
                  </a:rPr>
                  <a:t>RLU</a:t>
                </a:r>
              </a:p>
            </c:rich>
          </c:tx>
          <c:layout>
            <c:manualLayout>
              <c:xMode val="edge"/>
              <c:yMode val="edge"/>
              <c:x val="2.0822111204084413E-2"/>
              <c:y val="0.38070447750259839"/>
            </c:manualLayout>
          </c:layout>
          <c:overlay val="0"/>
        </c:title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308668912"/>
        <c:crosses val="autoZero"/>
        <c:crossBetween val="between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2637872420196125"/>
          <c:y val="5.1400554097404488E-2"/>
          <c:w val="0.85753510458544546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ysClr val="window" lastClr="FFFFFF">
                <a:lumMod val="85000"/>
              </a:sysClr>
            </a:solidFill>
            <a:ln>
              <a:solidFill>
                <a:schemeClr val="dk1">
                  <a:shade val="95000"/>
                  <a:satMod val="105000"/>
                </a:schemeClr>
              </a:solidFill>
            </a:ln>
          </c:spPr>
          <c:invertIfNegative val="0"/>
          <c:dPt>
            <c:idx val="0"/>
            <c:invertIfNegative val="0"/>
            <c:bubble3D val="0"/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</c:dPt>
          <c:dLbls>
            <c:numFmt formatCode="#,##0.0" sourceLinked="0"/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>
                    <a:latin typeface="Times New Roman" pitchFamily="18" charset="0"/>
                    <a:cs typeface="Times New Roman" pitchFamily="18" charset="0"/>
                  </a:defRPr>
                </a:pPr>
                <a:endParaRPr lang="en-US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Sheet1!$O$27:$O$30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8.7228144479315109E-2</c:v>
                  </c:pt>
                  <c:pt idx="2">
                    <c:v>9.2659149920078426E-2</c:v>
                  </c:pt>
                  <c:pt idx="3">
                    <c:v>0.15934095552034774</c:v>
                  </c:pt>
                </c:numCache>
              </c:numRef>
            </c:plus>
            <c:minus>
              <c:numRef>
                <c:f>Sheet1!$O$27:$O$30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8.7228144479315109E-2</c:v>
                  </c:pt>
                  <c:pt idx="2">
                    <c:v>9.2659149920078426E-2</c:v>
                  </c:pt>
                  <c:pt idx="3">
                    <c:v>0.15934095552034774</c:v>
                  </c:pt>
                </c:numCache>
              </c:numRef>
            </c:minus>
          </c:errBars>
          <c:cat>
            <c:strRef>
              <c:f>Sheet1!$M$27:$M$30</c:f>
              <c:strCache>
                <c:ptCount val="4"/>
                <c:pt idx="0">
                  <c:v>SOL</c:v>
                </c:pt>
                <c:pt idx="1">
                  <c:v>EDL</c:v>
                </c:pt>
                <c:pt idx="2">
                  <c:v>DIA</c:v>
                </c:pt>
                <c:pt idx="3">
                  <c:v>Heart</c:v>
                </c:pt>
              </c:strCache>
            </c:strRef>
          </c:cat>
          <c:val>
            <c:numRef>
              <c:f>Sheet1!$N$27:$N$30</c:f>
              <c:numCache>
                <c:formatCode>General</c:formatCode>
                <c:ptCount val="4"/>
                <c:pt idx="0">
                  <c:v>1.94</c:v>
                </c:pt>
                <c:pt idx="1">
                  <c:v>1.7867462110802592</c:v>
                </c:pt>
                <c:pt idx="2">
                  <c:v>1.2335333022228325</c:v>
                </c:pt>
                <c:pt idx="3">
                  <c:v>1.438936858330617</c:v>
                </c:pt>
              </c:numCache>
            </c:numRef>
          </c:val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302485024"/>
        <c:axId val="297676816"/>
      </c:barChart>
      <c:catAx>
        <c:axId val="3024850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297676816"/>
        <c:crosses val="autoZero"/>
        <c:auto val="1"/>
        <c:lblAlgn val="ctr"/>
        <c:lblOffset val="100"/>
        <c:noMultiLvlLbl val="0"/>
      </c:catAx>
      <c:valAx>
        <c:axId val="297676816"/>
        <c:scaling>
          <c:orientation val="minMax"/>
          <c:max val="2.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1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b="1">
                    <a:latin typeface="Times New Roman" pitchFamily="18" charset="0"/>
                    <a:cs typeface="Times New Roman" pitchFamily="18" charset="0"/>
                  </a:rPr>
                  <a:t>Utrophin protein expression (Fold difference, normalised to Vehicle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302485024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CB5A7-AF91-4389-9B13-99D5E102AA77}" type="datetimeFigureOut">
              <a:rPr lang="en-GB" smtClean="0"/>
              <a:t>2015-03-0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4AD7F-6480-4392-A762-1D3D5B67A8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8796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CB5A7-AF91-4389-9B13-99D5E102AA77}" type="datetimeFigureOut">
              <a:rPr lang="en-GB" smtClean="0"/>
              <a:t>2015-03-0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4AD7F-6480-4392-A762-1D3D5B67A8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64736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CB5A7-AF91-4389-9B13-99D5E102AA77}" type="datetimeFigureOut">
              <a:rPr lang="en-GB" smtClean="0"/>
              <a:t>2015-03-0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4AD7F-6480-4392-A762-1D3D5B67A8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62179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CB5A7-AF91-4389-9B13-99D5E102AA77}" type="datetimeFigureOut">
              <a:rPr lang="en-GB" smtClean="0"/>
              <a:t>2015-03-0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4AD7F-6480-4392-A762-1D3D5B67A8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69382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CB5A7-AF91-4389-9B13-99D5E102AA77}" type="datetimeFigureOut">
              <a:rPr lang="en-GB" smtClean="0"/>
              <a:t>2015-03-0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4AD7F-6480-4392-A762-1D3D5B67A8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14822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CB5A7-AF91-4389-9B13-99D5E102AA77}" type="datetimeFigureOut">
              <a:rPr lang="en-GB" smtClean="0"/>
              <a:t>2015-03-0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4AD7F-6480-4392-A762-1D3D5B67A8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24082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CB5A7-AF91-4389-9B13-99D5E102AA77}" type="datetimeFigureOut">
              <a:rPr lang="en-GB" smtClean="0"/>
              <a:t>2015-03-0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4AD7F-6480-4392-A762-1D3D5B67A8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40112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CB5A7-AF91-4389-9B13-99D5E102AA77}" type="datetimeFigureOut">
              <a:rPr lang="en-GB" smtClean="0"/>
              <a:t>2015-03-0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4AD7F-6480-4392-A762-1D3D5B67A8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63990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CB5A7-AF91-4389-9B13-99D5E102AA77}" type="datetimeFigureOut">
              <a:rPr lang="en-GB" smtClean="0"/>
              <a:t>2015-03-0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4AD7F-6480-4392-A762-1D3D5B67A8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770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CB5A7-AF91-4389-9B13-99D5E102AA77}" type="datetimeFigureOut">
              <a:rPr lang="en-GB" smtClean="0"/>
              <a:t>2015-03-0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4AD7F-6480-4392-A762-1D3D5B67A8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8767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CB5A7-AF91-4389-9B13-99D5E102AA77}" type="datetimeFigureOut">
              <a:rPr lang="en-GB" smtClean="0"/>
              <a:t>2015-03-0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4AD7F-6480-4392-A762-1D3D5B67A8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52119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4CB5A7-AF91-4389-9B13-99D5E102AA77}" type="datetimeFigureOut">
              <a:rPr lang="en-GB" smtClean="0"/>
              <a:t>2015-03-0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94AD7F-6480-4392-A762-1D3D5B67A8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52823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chart" Target="../charts/chart2.xml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086100" y="5120048"/>
            <a:ext cx="734377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Supplementary data 1</a:t>
            </a:r>
            <a:r>
              <a:rPr lang="en-GB" sz="14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GB" sz="1400" b="1" dirty="0">
                <a:latin typeface="Times New Roman" pitchFamily="18" charset="0"/>
                <a:cs typeface="Times New Roman" pitchFamily="18" charset="0"/>
              </a:rPr>
              <a:t>Proliferation rate </a:t>
            </a:r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GB" sz="1400" b="1" dirty="0">
                <a:latin typeface="Times New Roman" pitchFamily="18" charset="0"/>
                <a:cs typeface="Times New Roman" pitchFamily="18" charset="0"/>
              </a:rPr>
              <a:t>murine myoblasts after SMT022357 treatment</a:t>
            </a:r>
            <a:endParaRPr lang="en-GB" sz="1400" b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/>
          </p:nvPr>
        </p:nvGraphicFramePr>
        <p:xfrm>
          <a:off x="3031686" y="1511300"/>
          <a:ext cx="6709214" cy="34944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TextBox 1"/>
          <p:cNvSpPr txBox="1"/>
          <p:nvPr/>
        </p:nvSpPr>
        <p:spPr>
          <a:xfrm>
            <a:off x="3770978" y="4468642"/>
            <a:ext cx="585417" cy="246221"/>
          </a:xfrm>
          <a:prstGeom prst="rect">
            <a:avLst/>
          </a:prstGeom>
          <a:solidFill>
            <a:schemeClr val="bg1"/>
          </a:solidFill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dirty="0">
                <a:latin typeface="Times New Roman" pitchFamily="18" charset="0"/>
                <a:cs typeface="Times New Roman" pitchFamily="18" charset="0"/>
              </a:rPr>
              <a:t>Vehicle</a:t>
            </a:r>
          </a:p>
        </p:txBody>
      </p:sp>
    </p:spTree>
    <p:extLst>
      <p:ext uri="{BB962C8B-B14F-4D97-AF65-F5344CB8AC3E}">
        <p14:creationId xmlns:p14="http://schemas.microsoft.com/office/powerpoint/2010/main" val="41802990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Picture 1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25709" y="1726207"/>
            <a:ext cx="1163964" cy="1650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Rectangle 1"/>
          <p:cNvSpPr/>
          <p:nvPr/>
        </p:nvSpPr>
        <p:spPr>
          <a:xfrm>
            <a:off x="1819275" y="5442212"/>
            <a:ext cx="951547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Supplementary data 3</a:t>
            </a:r>
            <a:r>
              <a:rPr lang="en-GB" sz="14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GB" sz="1400" b="1" dirty="0">
                <a:latin typeface="Times New Roman" pitchFamily="18" charset="0"/>
                <a:cs typeface="Times New Roman" pitchFamily="18" charset="0"/>
              </a:rPr>
              <a:t>Utrophin, </a:t>
            </a:r>
            <a:r>
              <a:rPr lang="el-GR" sz="1400" b="1" dirty="0"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GB" sz="1400" b="1" dirty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GB" sz="1400" b="1" dirty="0" err="1">
                <a:latin typeface="Times New Roman" pitchFamily="18" charset="0"/>
                <a:cs typeface="Times New Roman" pitchFamily="18" charset="0"/>
              </a:rPr>
              <a:t>dystroglycan</a:t>
            </a:r>
            <a:r>
              <a:rPr lang="en-GB" sz="1400" b="1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GB" sz="1400" b="1" dirty="0" err="1">
                <a:latin typeface="Times New Roman" pitchFamily="18" charset="0"/>
                <a:cs typeface="Times New Roman" pitchFamily="18" charset="0"/>
              </a:rPr>
              <a:t>dystrobrevin</a:t>
            </a:r>
            <a:r>
              <a:rPr lang="en-GB" sz="1400" b="1" dirty="0">
                <a:latin typeface="Times New Roman" pitchFamily="18" charset="0"/>
                <a:cs typeface="Times New Roman" pitchFamily="18" charset="0"/>
              </a:rPr>
              <a:t> levels after 5 weeks of treatment with SMT022357</a:t>
            </a:r>
            <a:endParaRPr lang="en-GB" sz="1400" b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448915" y="1142739"/>
            <a:ext cx="4748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SOL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040631" y="1456890"/>
            <a:ext cx="5854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en-GB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533222" y="1471914"/>
            <a:ext cx="8322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Times New Roman" pitchFamily="18" charset="0"/>
                <a:cs typeface="Times New Roman" pitchFamily="18" charset="0"/>
              </a:rPr>
              <a:t>SMT022357</a:t>
            </a:r>
            <a:endParaRPr lang="en-GB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" name="Straight Connector 5"/>
          <p:cNvCxnSpPr/>
          <p:nvPr/>
        </p:nvCxnSpPr>
        <p:spPr>
          <a:xfrm>
            <a:off x="2119353" y="1429393"/>
            <a:ext cx="111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323066" y="1642324"/>
            <a:ext cx="7432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err="1" smtClean="0">
                <a:latin typeface="Times New Roman" pitchFamily="18" charset="0"/>
                <a:cs typeface="Times New Roman" pitchFamily="18" charset="0"/>
              </a:rPr>
              <a:t>Utrophin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306573" y="1879695"/>
            <a:ext cx="7793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GB" sz="1200" dirty="0" err="1" smtClean="0">
                <a:latin typeface="Times New Roman" pitchFamily="18" charset="0"/>
                <a:cs typeface="Times New Roman" pitchFamily="18" charset="0"/>
              </a:rPr>
              <a:t>Actinin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9535705" y="3182412"/>
            <a:ext cx="997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err="1" smtClean="0">
                <a:latin typeface="Times New Roman" pitchFamily="18" charset="0"/>
                <a:cs typeface="Times New Roman" pitchFamily="18" charset="0"/>
              </a:rPr>
              <a:t>Dystrobrevin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9563569" y="3446011"/>
            <a:ext cx="527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Actin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9440453" y="1667040"/>
            <a:ext cx="11448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GB" sz="1200" dirty="0" err="1" smtClean="0">
                <a:latin typeface="Times New Roman" pitchFamily="18" charset="0"/>
                <a:cs typeface="Times New Roman" pitchFamily="18" charset="0"/>
              </a:rPr>
              <a:t>Dystroglycan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9447189" y="1874561"/>
            <a:ext cx="7793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GB" sz="1200" dirty="0" err="1" smtClean="0">
                <a:latin typeface="Times New Roman" pitchFamily="18" charset="0"/>
                <a:cs typeface="Times New Roman" pitchFamily="18" charset="0"/>
              </a:rPr>
              <a:t>Actinin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63" name="Chart 62"/>
          <p:cNvGraphicFramePr>
            <a:graphicFrameLocks/>
          </p:cNvGraphicFramePr>
          <p:nvPr>
            <p:extLst/>
          </p:nvPr>
        </p:nvGraphicFramePr>
        <p:xfrm>
          <a:off x="1323066" y="2475793"/>
          <a:ext cx="6315984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64" name="Straight Connector 63"/>
          <p:cNvCxnSpPr/>
          <p:nvPr/>
        </p:nvCxnSpPr>
        <p:spPr>
          <a:xfrm flipV="1">
            <a:off x="2119353" y="3982065"/>
            <a:ext cx="5004000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TextBox 6"/>
          <p:cNvSpPr txBox="1"/>
          <p:nvPr/>
        </p:nvSpPr>
        <p:spPr>
          <a:xfrm>
            <a:off x="3985771" y="2875334"/>
            <a:ext cx="325217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dirty="0">
                <a:latin typeface="Times New Roman" pitchFamily="18" charset="0"/>
                <a:cs typeface="Times New Roman" pitchFamily="18" charset="0"/>
              </a:rPr>
              <a:t>**</a:t>
            </a:r>
          </a:p>
        </p:txBody>
      </p:sp>
      <p:sp>
        <p:nvSpPr>
          <p:cNvPr id="66" name="TextBox 7"/>
          <p:cNvSpPr txBox="1"/>
          <p:nvPr/>
        </p:nvSpPr>
        <p:spPr>
          <a:xfrm>
            <a:off x="6722978" y="3144018"/>
            <a:ext cx="254942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dirty="0">
                <a:latin typeface="Times New Roman" pitchFamily="18" charset="0"/>
                <a:cs typeface="Times New Roman" pitchFamily="18" charset="0"/>
              </a:rPr>
              <a:t>*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3765752" y="1133214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EDL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3338418" y="1447365"/>
            <a:ext cx="5854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en-GB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3831009" y="1462389"/>
            <a:ext cx="8322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Times New Roman" pitchFamily="18" charset="0"/>
                <a:cs typeface="Times New Roman" pitchFamily="18" charset="0"/>
              </a:rPr>
              <a:t>SMT022357</a:t>
            </a:r>
            <a:endParaRPr lang="en-GB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81" name="Straight Connector 80"/>
          <p:cNvCxnSpPr/>
          <p:nvPr/>
        </p:nvCxnSpPr>
        <p:spPr>
          <a:xfrm>
            <a:off x="3417140" y="1419868"/>
            <a:ext cx="111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TextBox 85"/>
          <p:cNvSpPr txBox="1"/>
          <p:nvPr/>
        </p:nvSpPr>
        <p:spPr>
          <a:xfrm>
            <a:off x="5151892" y="1123325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DIA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4734083" y="1437476"/>
            <a:ext cx="5854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en-GB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5226674" y="1452500"/>
            <a:ext cx="8322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Times New Roman" pitchFamily="18" charset="0"/>
                <a:cs typeface="Times New Roman" pitchFamily="18" charset="0"/>
              </a:rPr>
              <a:t>SMT022357</a:t>
            </a:r>
            <a:endParaRPr lang="en-GB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95" name="Straight Connector 94"/>
          <p:cNvCxnSpPr/>
          <p:nvPr/>
        </p:nvCxnSpPr>
        <p:spPr>
          <a:xfrm>
            <a:off x="4812805" y="1409979"/>
            <a:ext cx="111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0" name="TextBox 99"/>
          <p:cNvSpPr txBox="1"/>
          <p:nvPr/>
        </p:nvSpPr>
        <p:spPr>
          <a:xfrm>
            <a:off x="6462575" y="1114843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Heart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6073341" y="1428994"/>
            <a:ext cx="5854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en-GB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6565932" y="1444018"/>
            <a:ext cx="8322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Times New Roman" pitchFamily="18" charset="0"/>
                <a:cs typeface="Times New Roman" pitchFamily="18" charset="0"/>
              </a:rPr>
              <a:t>SMT022357</a:t>
            </a:r>
            <a:endParaRPr lang="en-GB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07" name="Straight Connector 106"/>
          <p:cNvCxnSpPr/>
          <p:nvPr/>
        </p:nvCxnSpPr>
        <p:spPr>
          <a:xfrm>
            <a:off x="6152063" y="1401497"/>
            <a:ext cx="111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4" name="TextBox 113"/>
          <p:cNvSpPr txBox="1"/>
          <p:nvPr/>
        </p:nvSpPr>
        <p:spPr>
          <a:xfrm>
            <a:off x="8574886" y="2610865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EDL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8223752" y="2925016"/>
            <a:ext cx="5854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en-GB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8716343" y="2940040"/>
            <a:ext cx="8322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Times New Roman" pitchFamily="18" charset="0"/>
                <a:cs typeface="Times New Roman" pitchFamily="18" charset="0"/>
              </a:rPr>
              <a:t>SMT022357</a:t>
            </a:r>
            <a:endParaRPr lang="en-GB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17" name="Straight Connector 116"/>
          <p:cNvCxnSpPr/>
          <p:nvPr/>
        </p:nvCxnSpPr>
        <p:spPr>
          <a:xfrm>
            <a:off x="8302474" y="2897519"/>
            <a:ext cx="111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2" name="TextBox 121"/>
          <p:cNvSpPr txBox="1"/>
          <p:nvPr/>
        </p:nvSpPr>
        <p:spPr>
          <a:xfrm>
            <a:off x="8535344" y="1107260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EDL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8165160" y="1411886"/>
            <a:ext cx="5854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en-GB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8638701" y="1407860"/>
            <a:ext cx="8322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Times New Roman" pitchFamily="18" charset="0"/>
                <a:cs typeface="Times New Roman" pitchFamily="18" charset="0"/>
              </a:rPr>
              <a:t>SMT022357</a:t>
            </a:r>
            <a:endParaRPr lang="en-GB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25" name="Straight Connector 124"/>
          <p:cNvCxnSpPr/>
          <p:nvPr/>
        </p:nvCxnSpPr>
        <p:spPr>
          <a:xfrm>
            <a:off x="8224832" y="1393914"/>
            <a:ext cx="111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6" name="TextBox 125"/>
          <p:cNvSpPr txBox="1"/>
          <p:nvPr/>
        </p:nvSpPr>
        <p:spPr>
          <a:xfrm>
            <a:off x="1306573" y="958073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Times New Roman" pitchFamily="18" charset="0"/>
                <a:cs typeface="Times New Roman" pitchFamily="18" charset="0"/>
              </a:rPr>
              <a:t>(A</a:t>
            </a:r>
            <a:r>
              <a:rPr lang="en-GB" b="1" dirty="0">
                <a:latin typeface="Times New Roman" pitchFamily="18" charset="0"/>
                <a:cs typeface="Times New Roman" pitchFamily="18" charset="0"/>
              </a:rPr>
              <a:t>)</a:t>
            </a:r>
          </a:p>
        </p:txBody>
      </p:sp>
      <p:sp>
        <p:nvSpPr>
          <p:cNvPr id="127" name="TextBox 126"/>
          <p:cNvSpPr txBox="1"/>
          <p:nvPr/>
        </p:nvSpPr>
        <p:spPr>
          <a:xfrm>
            <a:off x="7768785" y="958073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Times New Roman" pitchFamily="18" charset="0"/>
                <a:cs typeface="Times New Roman" pitchFamily="18" charset="0"/>
              </a:rPr>
              <a:t>(B)</a:t>
            </a:r>
            <a:endParaRPr lang="en-GB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3" name="Picture 1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25709" y="1974613"/>
            <a:ext cx="1163964" cy="1146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5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7341" y="1962264"/>
            <a:ext cx="1177926" cy="1091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6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7341" y="1726207"/>
            <a:ext cx="1177926" cy="1709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7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2805" y="1718135"/>
            <a:ext cx="1177926" cy="1748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8" name="Picture 8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2805" y="1957808"/>
            <a:ext cx="1177926" cy="113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9" name="Picture 13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2063" y="1721264"/>
            <a:ext cx="1177926" cy="1560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0" name="Picture 14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0203" y="1957808"/>
            <a:ext cx="1179786" cy="1136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" name="Picture 15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83489" y="3249550"/>
            <a:ext cx="1161658" cy="149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2" name="Picture 16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91174" y="3509264"/>
            <a:ext cx="1177926" cy="150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9" name="Picture 9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27565" y="1703111"/>
            <a:ext cx="1177926" cy="1816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0" name="Picture 10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43549" y="1974613"/>
            <a:ext cx="1161658" cy="968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783727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4</Words>
  <Application>Microsoft Office PowerPoint</Application>
  <PresentationFormat>Widescreen</PresentationFormat>
  <Paragraphs>3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University of Oxfor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son, Helen J</dc:creator>
  <cp:lastModifiedBy>Johnson, Helen J</cp:lastModifiedBy>
  <cp:revision>1</cp:revision>
  <dcterms:created xsi:type="dcterms:W3CDTF">2015-03-09T09:56:01Z</dcterms:created>
  <dcterms:modified xsi:type="dcterms:W3CDTF">2015-03-09T09:56:15Z</dcterms:modified>
</cp:coreProperties>
</file>